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7" r:id="rId2"/>
    <p:sldId id="263" r:id="rId3"/>
    <p:sldId id="262" r:id="rId4"/>
    <p:sldId id="264" r:id="rId5"/>
    <p:sldId id="266" r:id="rId6"/>
    <p:sldId id="265" r:id="rId7"/>
    <p:sldId id="260" r:id="rId8"/>
    <p:sldId id="267" r:id="rId9"/>
    <p:sldId id="261" r:id="rId10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36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60CE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5" autoAdjust="0"/>
    <p:restoredTop sz="96301" autoAdjust="0"/>
  </p:normalViewPr>
  <p:slideViewPr>
    <p:cSldViewPr snapToGrid="0" showGuides="1">
      <p:cViewPr varScale="1">
        <p:scale>
          <a:sx n="97" d="100"/>
          <a:sy n="97" d="100"/>
        </p:scale>
        <p:origin x="828" y="78"/>
      </p:cViewPr>
      <p:guideLst>
        <p:guide orient="horz" pos="2636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079953-0B2C-4289-87FC-2E06502ED864}" type="datetimeFigureOut">
              <a:rPr lang="de-DE" smtClean="0"/>
              <a:t>19.09.20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24183D-670B-4D1E-92FB-5D7AB87EE8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86453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24183D-670B-4D1E-92FB-5D7AB87EE8FD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50707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24183D-670B-4D1E-92FB-5D7AB87EE8FD}" type="slidenum">
              <a:rPr lang="de-DE" smtClean="0"/>
              <a:t>4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616507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24183D-670B-4D1E-92FB-5D7AB87EE8FD}" type="slidenum">
              <a:rPr lang="de-DE" smtClean="0"/>
              <a:t>5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949493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24183D-670B-4D1E-92FB-5D7AB87EE8FD}" type="slidenum">
              <a:rPr lang="de-DE" smtClean="0"/>
              <a:t>7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290728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24183D-670B-4D1E-92FB-5D7AB87EE8FD}" type="slidenum">
              <a:rPr lang="de-DE" smtClean="0"/>
              <a:t>9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66709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BEE5E9B-95E9-5E9C-8DEB-7B80A38092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F2EA837E-1831-65AB-7FCA-CF13A34722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7CAC663-644A-C148-C85A-197441BA8D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DD980-4DA0-4408-A790-5B1161CBE19E}" type="datetimeFigureOut">
              <a:rPr lang="de-DE" smtClean="0"/>
              <a:t>19.09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6E7552C-0E97-CAA3-D356-B967A9CB72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C85DA33-0D29-C6D8-B593-B92891322D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BE43-DC45-40CF-AD35-10C16EBBE7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5142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DD8EDAE-4165-C1F1-57A9-FB25E19616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2FE20B65-D5BE-8208-F41B-0DF3F3E07D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6F9BE2D-B03E-ED3E-9F48-6793111691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DD980-4DA0-4408-A790-5B1161CBE19E}" type="datetimeFigureOut">
              <a:rPr lang="de-DE" smtClean="0"/>
              <a:t>19.09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1082996-EB11-2DFB-B9F1-5EC4295E12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351FB7F-37B9-0E85-9C64-80EA05FE05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BE43-DC45-40CF-AD35-10C16EBBE7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1639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30F08D3C-1FAD-784E-597C-EE67DC88441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42DA899-98AB-B247-5304-AB7AA5A157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E399AE6-9411-3D4B-45E9-BBF8FE94A6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DD980-4DA0-4408-A790-5B1161CBE19E}" type="datetimeFigureOut">
              <a:rPr lang="de-DE" smtClean="0"/>
              <a:t>19.09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FF753D6-009A-10FE-4267-58908DB420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4F292C8-A651-FA22-A6EA-CF241E0C26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BE43-DC45-40CF-AD35-10C16EBBE7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150684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540C77E-ABBC-F1D7-49F3-C8B852E48D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C620288-5DD6-C294-F78E-6E89C8A0FF8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004F9FD-7E4E-8A17-8241-0E29E3C497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DD980-4DA0-4408-A790-5B1161CBE19E}" type="datetimeFigureOut">
              <a:rPr lang="de-DE" smtClean="0"/>
              <a:t>19.09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F7911CE-F7E1-FF54-D129-117BB890C4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72AE706-41C3-FAB7-3AB7-8AA4B0E887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BE43-DC45-40CF-AD35-10C16EBBE7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0860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5202D4F-F197-2133-FE74-C2184DF7B1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A8C2064-37AD-5A87-484A-1F15D59321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E29B5AD-5263-2F45-A7B5-A0BB39A8E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DD980-4DA0-4408-A790-5B1161CBE19E}" type="datetimeFigureOut">
              <a:rPr lang="de-DE" smtClean="0"/>
              <a:t>19.09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64B8FD6-95F6-C374-94B6-5031ECF305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3EB39FB-305B-C267-33D2-5922FBCF8A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BE43-DC45-40CF-AD35-10C16EBBE7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2664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E0C1447-3145-6098-27F2-D25F2F4C48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E909872-EC21-D9F5-1890-677AAA253C7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5C4E7529-F7D6-1B84-E41F-9CABCA44DA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B55CE11-6BDE-866F-FE62-E7DEEF02C9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DD980-4DA0-4408-A790-5B1161CBE19E}" type="datetimeFigureOut">
              <a:rPr lang="de-DE" smtClean="0"/>
              <a:t>19.09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7968240-CE05-CD61-D6AB-B92E97BFB2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200AD08-6137-8165-D9FC-9FE61193D3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BE43-DC45-40CF-AD35-10C16EBBE7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02849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646B1C2-9451-AB3F-F73A-59548FA461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58D793D-324D-CE7F-1B81-AD82F159CD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E0CE084-1B0E-A646-1FB4-0A4AF4E89B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34AF010C-F2D5-63C7-6E48-F389D2E065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2A5D7B74-6717-3760-312D-0AF3D127D7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73408E39-8A4F-5024-61B1-8E053D5765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DD980-4DA0-4408-A790-5B1161CBE19E}" type="datetimeFigureOut">
              <a:rPr lang="de-DE" smtClean="0"/>
              <a:t>19.09.20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251D0693-AFCC-9C45-01D8-5771EC9D30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47AA4D49-83CA-BD16-7AF6-15F2454889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BE43-DC45-40CF-AD35-10C16EBBE7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53231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A8FBCE0-0C43-5FBA-46C7-64E4ED3D03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E70862F1-D7F1-40E9-C4C9-FAB68AF7FB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DD980-4DA0-4408-A790-5B1161CBE19E}" type="datetimeFigureOut">
              <a:rPr lang="de-DE" smtClean="0"/>
              <a:t>19.09.20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7BC46493-F9E7-DAB8-71CF-7D468024FC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FAA278BE-0E5C-07FC-7A12-F24CC76651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BE43-DC45-40CF-AD35-10C16EBBE7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7076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85D76F13-A352-0202-4586-825A8E27FF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DD980-4DA0-4408-A790-5B1161CBE19E}" type="datetimeFigureOut">
              <a:rPr lang="de-DE" smtClean="0"/>
              <a:t>19.09.20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62F1A38D-2B3F-1C5C-353E-FB3701F2D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F6F00E39-7E57-F411-811F-AABF385E22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BE43-DC45-40CF-AD35-10C16EBBE7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3538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1E521C9-809B-15AC-3D46-55F608BFCF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3065722-AA84-72C0-F05C-E2D67A57479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E7ACB720-0D38-43C0-D500-9BEFE79E7A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3707D12-B643-AECD-F4CA-1DF9287C00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DD980-4DA0-4408-A790-5B1161CBE19E}" type="datetimeFigureOut">
              <a:rPr lang="de-DE" smtClean="0"/>
              <a:t>19.09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46E18A7-2A46-5A78-1D89-23E179EDC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93BE67A-C4DF-17F2-E04F-5D34545443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BE43-DC45-40CF-AD35-10C16EBBE7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76386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C68F35E-7907-1FB0-CB46-DBB9315520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1839F864-414F-EDA2-884B-7A48C7B7250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35BF995-4C7F-C698-2ADC-39C73B0316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73A4A807-8DA7-CA4A-67EF-5CB1A436BC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DD980-4DA0-4408-A790-5B1161CBE19E}" type="datetimeFigureOut">
              <a:rPr lang="de-DE" smtClean="0"/>
              <a:t>19.09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F34E2C4-8153-FC9E-4748-E5D7400D3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3F912B6-E094-8AA0-2CC0-FB096A566F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BE43-DC45-40CF-AD35-10C16EBBE7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18821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F2F84541-4B18-2547-955B-DEEFE53E21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8BDA4BA-E265-9C25-9843-1A48614DD5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16AD27E-7134-6E5A-C0FB-CFC0B6ABE7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63DD980-4DA0-4408-A790-5B1161CBE19E}" type="datetimeFigureOut">
              <a:rPr lang="de-DE" smtClean="0"/>
              <a:t>19.09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2B9C5BF-A2FC-4C91-19EE-F3B01450A2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8AD3C2E-41F1-FD6D-250F-49EE5144019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54CBE43-DC45-40CF-AD35-10C16EBBE7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2708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emf"/><Relationship Id="rId4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e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4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emf"/><Relationship Id="rId3" Type="http://schemas.openxmlformats.org/officeDocument/2006/relationships/image" Target="../media/image25.emf"/><Relationship Id="rId7" Type="http://schemas.openxmlformats.org/officeDocument/2006/relationships/image" Target="../media/image29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4" Type="http://schemas.openxmlformats.org/officeDocument/2006/relationships/image" Target="../media/image26.png"/><Relationship Id="rId9" Type="http://schemas.openxmlformats.org/officeDocument/2006/relationships/image" Target="../media/image3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603138" y="550662"/>
            <a:ext cx="9903318" cy="369331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</a:pP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n=147</a:t>
            </a:r>
            <a:endParaRPr lang="de-DE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>
              <a:lnSpc>
                <a:spcPct val="200000"/>
              </a:lnSpc>
            </a:pPr>
            <a:endParaRPr lang="de-DE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>
              <a:lnSpc>
                <a:spcPct val="200000"/>
              </a:lnSpc>
            </a:pP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n=139</a:t>
            </a:r>
            <a:endParaRPr lang="de-DE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/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                                                       </a:t>
            </a:r>
          </a:p>
          <a:p>
            <a:pPr algn="ctr"/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                                         </a:t>
            </a:r>
          </a:p>
          <a:p>
            <a:pPr algn="ctr">
              <a:lnSpc>
                <a:spcPct val="200000"/>
              </a:lnSpc>
            </a:pPr>
            <a:endParaRPr lang="de-DE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/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                                              </a:t>
            </a:r>
            <a:endParaRPr lang="de-DE" b="1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/>
            <a:endParaRPr lang="de-DE" b="1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/>
            <a:r>
              <a:rPr lang="de-DE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n=107</a:t>
            </a:r>
            <a:endParaRPr lang="de-DE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6" name="Gerade Verbindung mit Pfeil 5"/>
          <p:cNvCxnSpPr/>
          <p:nvPr/>
        </p:nvCxnSpPr>
        <p:spPr>
          <a:xfrm>
            <a:off x="9144000" y="1434437"/>
            <a:ext cx="432000" cy="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 Verbindung mit Pfeil 17"/>
          <p:cNvCxnSpPr/>
          <p:nvPr/>
        </p:nvCxnSpPr>
        <p:spPr>
          <a:xfrm>
            <a:off x="9143066" y="3026063"/>
            <a:ext cx="432000" cy="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Ellipse 18"/>
          <p:cNvSpPr/>
          <p:nvPr/>
        </p:nvSpPr>
        <p:spPr>
          <a:xfrm>
            <a:off x="4876700" y="3721327"/>
            <a:ext cx="1377863" cy="626301"/>
          </a:xfrm>
          <a:prstGeom prst="ellipse">
            <a:avLst/>
          </a:prstGeom>
          <a:noFill/>
          <a:ln>
            <a:solidFill>
              <a:schemeClr val="tx2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9732261" y="1468214"/>
            <a:ext cx="928459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n=4 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AT/RT</a:t>
            </a:r>
          </a:p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n=2 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ETMR</a:t>
            </a:r>
          </a:p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n=1 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GBM</a:t>
            </a:r>
          </a:p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n=1 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MB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6529361" y="3775688"/>
            <a:ext cx="40254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       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all with 850k and MIP;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103 with 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NGS</a:t>
            </a:r>
          </a:p>
        </p:txBody>
      </p:sp>
      <p:cxnSp>
        <p:nvCxnSpPr>
          <p:cNvPr id="23" name="Gerade Verbindung mit Pfeil 22"/>
          <p:cNvCxnSpPr/>
          <p:nvPr/>
        </p:nvCxnSpPr>
        <p:spPr>
          <a:xfrm>
            <a:off x="5568787" y="1244948"/>
            <a:ext cx="0" cy="486290"/>
          </a:xfrm>
          <a:prstGeom prst="straightConnector1">
            <a:avLst/>
          </a:prstGeom>
          <a:ln w="38100">
            <a:solidFill>
              <a:schemeClr val="tx1">
                <a:lumMod val="85000"/>
                <a:lumOff val="1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feld 4">
            <a:extLst>
              <a:ext uri="{FF2B5EF4-FFF2-40B4-BE49-F238E27FC236}">
                <a16:creationId xmlns:a16="http://schemas.microsoft.com/office/drawing/2014/main" id="{D97DC672-C928-9D66-28D1-433475754F5F}"/>
              </a:ext>
            </a:extLst>
          </p:cNvPr>
          <p:cNvSpPr txBox="1"/>
          <p:nvPr/>
        </p:nvSpPr>
        <p:spPr>
          <a:xfrm>
            <a:off x="5969721" y="1239157"/>
            <a:ext cx="43503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other tumor entities                                 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n=8</a:t>
            </a:r>
            <a:endParaRPr lang="de-DE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34CB8E3A-4AAC-38B2-5AFF-C88222B7A06F}"/>
              </a:ext>
            </a:extLst>
          </p:cNvPr>
          <p:cNvSpPr txBox="1"/>
          <p:nvPr/>
        </p:nvSpPr>
        <p:spPr>
          <a:xfrm>
            <a:off x="5969721" y="2561399"/>
            <a:ext cx="436273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excluded because of</a:t>
            </a:r>
          </a:p>
          <a:p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poor quality / too few material;       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    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 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n=32</a:t>
            </a:r>
            <a:endParaRPr lang="de-DE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inconclusive subtyping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BBCD4834-5505-E364-513C-FE2C64294D74}"/>
              </a:ext>
            </a:extLst>
          </p:cNvPr>
          <p:cNvSpPr txBox="1"/>
          <p:nvPr/>
        </p:nvSpPr>
        <p:spPr>
          <a:xfrm>
            <a:off x="695408" y="1985812"/>
            <a:ext cx="2266454" cy="58477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sz="16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Supplementary Figure 1:</a:t>
            </a:r>
          </a:p>
          <a:p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Study cohort overview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0" name="Gerade Verbindung mit Pfeil 9">
            <a:extLst>
              <a:ext uri="{FF2B5EF4-FFF2-40B4-BE49-F238E27FC236}">
                <a16:creationId xmlns:a16="http://schemas.microsoft.com/office/drawing/2014/main" id="{173D1A8E-260E-C527-F070-BCE7EE82E9C8}"/>
              </a:ext>
            </a:extLst>
          </p:cNvPr>
          <p:cNvCxnSpPr/>
          <p:nvPr/>
        </p:nvCxnSpPr>
        <p:spPr>
          <a:xfrm>
            <a:off x="5568787" y="2625302"/>
            <a:ext cx="0" cy="792000"/>
          </a:xfrm>
          <a:prstGeom prst="straightConnector1">
            <a:avLst/>
          </a:prstGeom>
          <a:ln w="38100">
            <a:solidFill>
              <a:schemeClr val="tx1">
                <a:lumMod val="85000"/>
                <a:lumOff val="1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feld 10">
            <a:extLst>
              <a:ext uri="{FF2B5EF4-FFF2-40B4-BE49-F238E27FC236}">
                <a16:creationId xmlns:a16="http://schemas.microsoft.com/office/drawing/2014/main" id="{04C60B45-B25D-A6D0-A0CD-7F10B39E5781}"/>
              </a:ext>
            </a:extLst>
          </p:cNvPr>
          <p:cNvSpPr txBox="1"/>
          <p:nvPr/>
        </p:nvSpPr>
        <p:spPr>
          <a:xfrm>
            <a:off x="5044046" y="281412"/>
            <a:ext cx="10599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>
                <a:latin typeface="Calibri" panose="020F0502020204030204" pitchFamily="34" charset="0"/>
                <a:cs typeface="Calibri" panose="020F0502020204030204" pitchFamily="34" charset="0"/>
              </a:rPr>
              <a:t>Cohort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B8E81176-2691-756B-D6FB-F9D5618893E6}"/>
              </a:ext>
            </a:extLst>
          </p:cNvPr>
          <p:cNvSpPr txBox="1"/>
          <p:nvPr/>
        </p:nvSpPr>
        <p:spPr>
          <a:xfrm>
            <a:off x="557129" y="4681776"/>
            <a:ext cx="115261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n=83 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Pineoblastoma         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n=15 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PPTID         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n=6 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Pineocytoma         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      n=2 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Pineal anlage tumor       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n=1 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Ectopic WNT-MB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832DC196-0BC0-E520-3839-6DE5E99FB8B0}"/>
              </a:ext>
            </a:extLst>
          </p:cNvPr>
          <p:cNvSpPr txBox="1"/>
          <p:nvPr/>
        </p:nvSpPr>
        <p:spPr>
          <a:xfrm>
            <a:off x="1812766" y="5769450"/>
            <a:ext cx="90131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n=40 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PB-miRNA1A    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n=8 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PB-miRNA1B 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  n=19 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PB-miRNA2   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n=8 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PB-MYC/FOXR2    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n=8 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PB-RB1</a:t>
            </a:r>
          </a:p>
        </p:txBody>
      </p:sp>
      <p:sp>
        <p:nvSpPr>
          <p:cNvPr id="14" name="Pfeil: gebogen 13">
            <a:extLst>
              <a:ext uri="{FF2B5EF4-FFF2-40B4-BE49-F238E27FC236}">
                <a16:creationId xmlns:a16="http://schemas.microsoft.com/office/drawing/2014/main" id="{58E9D7CC-8EDB-F25E-ABB7-E3D393AC830D}"/>
              </a:ext>
            </a:extLst>
          </p:cNvPr>
          <p:cNvSpPr/>
          <p:nvPr/>
        </p:nvSpPr>
        <p:spPr>
          <a:xfrm rot="10800000" flipH="1">
            <a:off x="1316735" y="5040598"/>
            <a:ext cx="325453" cy="1014668"/>
          </a:xfrm>
          <a:prstGeom prst="bentArrow">
            <a:avLst>
              <a:gd name="adj1" fmla="val 25000"/>
              <a:gd name="adj2" fmla="val 25000"/>
              <a:gd name="adj3" fmla="val 25000"/>
              <a:gd name="adj4" fmla="val 33763"/>
            </a:avLst>
          </a:prstGeom>
          <a:solidFill>
            <a:schemeClr val="tx2">
              <a:lumMod val="75000"/>
              <a:lumOff val="25000"/>
            </a:schemeClr>
          </a:solidFill>
          <a:ln w="38100">
            <a:noFill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Pfeil: gebogen 14">
            <a:extLst>
              <a:ext uri="{FF2B5EF4-FFF2-40B4-BE49-F238E27FC236}">
                <a16:creationId xmlns:a16="http://schemas.microsoft.com/office/drawing/2014/main" id="{AA24204D-CED7-967D-4EAE-61E7C7B2E51C}"/>
              </a:ext>
            </a:extLst>
          </p:cNvPr>
          <p:cNvSpPr/>
          <p:nvPr/>
        </p:nvSpPr>
        <p:spPr>
          <a:xfrm rot="10800000" flipH="1">
            <a:off x="3591731" y="5003534"/>
            <a:ext cx="333380" cy="488729"/>
          </a:xfrm>
          <a:prstGeom prst="bentArrow">
            <a:avLst>
              <a:gd name="adj1" fmla="val 25000"/>
              <a:gd name="adj2" fmla="val 25000"/>
              <a:gd name="adj3" fmla="val 25000"/>
              <a:gd name="adj4" fmla="val 33763"/>
            </a:avLst>
          </a:prstGeom>
          <a:solidFill>
            <a:schemeClr val="tx2">
              <a:lumMod val="75000"/>
              <a:lumOff val="25000"/>
            </a:schemeClr>
          </a:solidFill>
          <a:ln w="38100">
            <a:noFill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40839687-82C4-1986-D175-385BE76E56B8}"/>
              </a:ext>
            </a:extLst>
          </p:cNvPr>
          <p:cNvSpPr txBox="1"/>
          <p:nvPr/>
        </p:nvSpPr>
        <p:spPr>
          <a:xfrm>
            <a:off x="2703501" y="5211919"/>
            <a:ext cx="40939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                       n=11 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PPTID-A    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n=4 PPTID-B</a:t>
            </a:r>
          </a:p>
        </p:txBody>
      </p:sp>
      <p:cxnSp>
        <p:nvCxnSpPr>
          <p:cNvPr id="24" name="Gerade Verbindung mit Pfeil 23">
            <a:extLst>
              <a:ext uri="{FF2B5EF4-FFF2-40B4-BE49-F238E27FC236}">
                <a16:creationId xmlns:a16="http://schemas.microsoft.com/office/drawing/2014/main" id="{2B11237E-21AF-FCF8-08A9-9D0E660A01BE}"/>
              </a:ext>
            </a:extLst>
          </p:cNvPr>
          <p:cNvCxnSpPr>
            <a:cxnSpLocks/>
          </p:cNvCxnSpPr>
          <p:nvPr/>
        </p:nvCxnSpPr>
        <p:spPr>
          <a:xfrm flipH="1">
            <a:off x="1789660" y="4201039"/>
            <a:ext cx="3010940" cy="480737"/>
          </a:xfrm>
          <a:prstGeom prst="straightConnector1">
            <a:avLst/>
          </a:prstGeom>
          <a:ln w="38100">
            <a:solidFill>
              <a:schemeClr val="tx2">
                <a:lumMod val="75000"/>
                <a:lumOff val="2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 Verbindung mit Pfeil 27">
            <a:extLst>
              <a:ext uri="{FF2B5EF4-FFF2-40B4-BE49-F238E27FC236}">
                <a16:creationId xmlns:a16="http://schemas.microsoft.com/office/drawing/2014/main" id="{02469680-B67F-C344-E501-C0CA5FFFDFD2}"/>
              </a:ext>
            </a:extLst>
          </p:cNvPr>
          <p:cNvCxnSpPr>
            <a:cxnSpLocks/>
          </p:cNvCxnSpPr>
          <p:nvPr/>
        </p:nvCxnSpPr>
        <p:spPr>
          <a:xfrm flipH="1">
            <a:off x="3874077" y="4345106"/>
            <a:ext cx="1002623" cy="369332"/>
          </a:xfrm>
          <a:prstGeom prst="straightConnector1">
            <a:avLst/>
          </a:prstGeom>
          <a:ln w="38100">
            <a:solidFill>
              <a:schemeClr val="tx2">
                <a:lumMod val="75000"/>
                <a:lumOff val="2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Gerade Verbindung mit Pfeil 29">
            <a:extLst>
              <a:ext uri="{FF2B5EF4-FFF2-40B4-BE49-F238E27FC236}">
                <a16:creationId xmlns:a16="http://schemas.microsoft.com/office/drawing/2014/main" id="{7C8D5E9D-BEA9-3548-ABC1-08878BAA23F5}"/>
              </a:ext>
            </a:extLst>
          </p:cNvPr>
          <p:cNvCxnSpPr>
            <a:cxnSpLocks/>
          </p:cNvCxnSpPr>
          <p:nvPr/>
        </p:nvCxnSpPr>
        <p:spPr>
          <a:xfrm>
            <a:off x="5568950" y="4500440"/>
            <a:ext cx="0" cy="220531"/>
          </a:xfrm>
          <a:prstGeom prst="straightConnector1">
            <a:avLst/>
          </a:prstGeom>
          <a:ln w="38100">
            <a:solidFill>
              <a:schemeClr val="tx2">
                <a:lumMod val="75000"/>
                <a:lumOff val="2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Gerade Verbindung mit Pfeil 31">
            <a:extLst>
              <a:ext uri="{FF2B5EF4-FFF2-40B4-BE49-F238E27FC236}">
                <a16:creationId xmlns:a16="http://schemas.microsoft.com/office/drawing/2014/main" id="{7E67A5E1-ABA6-034A-F948-4C8833C8DA0D}"/>
              </a:ext>
            </a:extLst>
          </p:cNvPr>
          <p:cNvCxnSpPr>
            <a:cxnSpLocks/>
          </p:cNvCxnSpPr>
          <p:nvPr/>
        </p:nvCxnSpPr>
        <p:spPr>
          <a:xfrm>
            <a:off x="6254563" y="4347628"/>
            <a:ext cx="1377863" cy="327048"/>
          </a:xfrm>
          <a:prstGeom prst="straightConnector1">
            <a:avLst/>
          </a:prstGeom>
          <a:ln w="38100">
            <a:solidFill>
              <a:schemeClr val="tx2">
                <a:lumMod val="75000"/>
                <a:lumOff val="2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 Verbindung mit Pfeil 34">
            <a:extLst>
              <a:ext uri="{FF2B5EF4-FFF2-40B4-BE49-F238E27FC236}">
                <a16:creationId xmlns:a16="http://schemas.microsoft.com/office/drawing/2014/main" id="{6F29C2EC-3A84-9545-0231-63646B60140B}"/>
              </a:ext>
            </a:extLst>
          </p:cNvPr>
          <p:cNvCxnSpPr>
            <a:cxnSpLocks/>
          </p:cNvCxnSpPr>
          <p:nvPr/>
        </p:nvCxnSpPr>
        <p:spPr>
          <a:xfrm>
            <a:off x="6324600" y="4215616"/>
            <a:ext cx="4157170" cy="459060"/>
          </a:xfrm>
          <a:prstGeom prst="straightConnector1">
            <a:avLst/>
          </a:prstGeom>
          <a:ln w="38100">
            <a:solidFill>
              <a:schemeClr val="tx2">
                <a:lumMod val="75000"/>
                <a:lumOff val="2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mit Pfeil 26"/>
          <p:cNvCxnSpPr/>
          <p:nvPr/>
        </p:nvCxnSpPr>
        <p:spPr>
          <a:xfrm>
            <a:off x="6489474" y="3985887"/>
            <a:ext cx="432000" cy="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Eckige Klammer links 19"/>
          <p:cNvSpPr/>
          <p:nvPr/>
        </p:nvSpPr>
        <p:spPr>
          <a:xfrm>
            <a:off x="9750549" y="1529923"/>
            <a:ext cx="79251" cy="846304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>
              <a:ln w="0">
                <a:solidFill>
                  <a:schemeClr val="tx1"/>
                </a:solidFill>
              </a:ln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25" name="Eckige Klammer rechts 24"/>
          <p:cNvSpPr/>
          <p:nvPr/>
        </p:nvSpPr>
        <p:spPr>
          <a:xfrm>
            <a:off x="10540728" y="1529923"/>
            <a:ext cx="64008" cy="846304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>
              <a:ln w="0">
                <a:solidFill>
                  <a:schemeClr val="tx1"/>
                </a:solidFill>
              </a:ln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832DC196-0BC0-E520-3839-6DE5E99FB8B0}"/>
              </a:ext>
            </a:extLst>
          </p:cNvPr>
          <p:cNvSpPr txBox="1"/>
          <p:nvPr/>
        </p:nvSpPr>
        <p:spPr>
          <a:xfrm>
            <a:off x="630875" y="5977834"/>
            <a:ext cx="102362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Clin. 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ohort: n=27 </a:t>
            </a:r>
            <a:r>
              <a:rPr lang="de-DE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B-miRNA1A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    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n=5 </a:t>
            </a:r>
            <a:r>
              <a:rPr lang="de-DE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B-miRNA1B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 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  n=13 </a:t>
            </a:r>
            <a:r>
              <a:rPr lang="de-DE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B-miRNA2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   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n=5 </a:t>
            </a:r>
            <a:r>
              <a:rPr lang="de-DE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B-MYC/FOXR2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    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n=5 </a:t>
            </a:r>
            <a:r>
              <a:rPr lang="de-DE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B-RB1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40839687-82C4-1986-D175-385BE76E56B8}"/>
              </a:ext>
            </a:extLst>
          </p:cNvPr>
          <p:cNvSpPr txBox="1"/>
          <p:nvPr/>
        </p:nvSpPr>
        <p:spPr>
          <a:xfrm>
            <a:off x="2725268" y="5401641"/>
            <a:ext cx="33797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Clin. 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ohort: n=4 </a:t>
            </a:r>
            <a:r>
              <a:rPr lang="de-DE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PTID-A 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2000" dirty="0">
                <a:latin typeface="Calibri" panose="020F0502020204030204" pitchFamily="34" charset="0"/>
                <a:cs typeface="Calibri" panose="020F0502020204030204" pitchFamily="34" charset="0"/>
              </a:rPr>
              <a:t>  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  n=1</a:t>
            </a:r>
            <a:endParaRPr lang="de-DE" dirty="0" smtClean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40839687-82C4-1986-D175-385BE76E56B8}"/>
              </a:ext>
            </a:extLst>
          </p:cNvPr>
          <p:cNvSpPr txBox="1"/>
          <p:nvPr/>
        </p:nvSpPr>
        <p:spPr>
          <a:xfrm>
            <a:off x="4570552" y="4853248"/>
            <a:ext cx="74721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Clin. 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ohort: n=1</a:t>
            </a:r>
            <a:r>
              <a:rPr lang="de-DE" dirty="0" smtClean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PT          </a:t>
            </a:r>
            <a:r>
              <a:rPr lang="de-DE" sz="2000" dirty="0" smtClean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Clin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. cohort: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n=1</a:t>
            </a:r>
            <a:r>
              <a:rPr lang="de-DE" dirty="0" smtClean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P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           </a:t>
            </a:r>
            <a:r>
              <a:rPr lang="de-DE" sz="2000" dirty="0" smtClean="0">
                <a:latin typeface="Calibri" panose="020F0502020204030204" pitchFamily="34" charset="0"/>
                <a:cs typeface="Calibri" panose="020F0502020204030204" pitchFamily="34" charset="0"/>
              </a:rPr>
              <a:t>  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  Clin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. cohort: n=1</a:t>
            </a:r>
            <a:r>
              <a:rPr lang="de-DE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PT </a:t>
            </a:r>
            <a:r>
              <a:rPr lang="de-DE" dirty="0" smtClean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T </a:t>
            </a:r>
          </a:p>
        </p:txBody>
      </p:sp>
      <p:sp>
        <p:nvSpPr>
          <p:cNvPr id="2" name="Textfeld 1"/>
          <p:cNvSpPr txBox="1"/>
          <p:nvPr/>
        </p:nvSpPr>
        <p:spPr>
          <a:xfrm>
            <a:off x="695408" y="371838"/>
            <a:ext cx="3348608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Goschzik et al.</a:t>
            </a:r>
          </a:p>
          <a:p>
            <a:pPr algn="ctr"/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Recurrent </a:t>
            </a:r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genetic alterations in epigenetically defined </a:t>
            </a:r>
            <a:endParaRPr lang="de-DE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/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pineoblastoma </a:t>
            </a:r>
            <a:r>
              <a:rPr lang="en-US" sz="16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subtypes</a:t>
            </a:r>
            <a:endParaRPr lang="de-DE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29295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" name="Grafik 10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40011" y="2882918"/>
            <a:ext cx="8284423" cy="3158464"/>
          </a:xfrm>
          <a:prstGeom prst="rect">
            <a:avLst/>
          </a:prstGeom>
        </p:spPr>
      </p:pic>
      <p:sp>
        <p:nvSpPr>
          <p:cNvPr id="102" name="Textfeld 101"/>
          <p:cNvSpPr txBox="1"/>
          <p:nvPr/>
        </p:nvSpPr>
        <p:spPr>
          <a:xfrm>
            <a:off x="3629588" y="3500720"/>
            <a:ext cx="9829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UMAP plot</a:t>
            </a:r>
            <a:endParaRPr lang="de-DE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04" name="Grafik 10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2805" y="246926"/>
            <a:ext cx="4781376" cy="3074168"/>
          </a:xfrm>
          <a:prstGeom prst="rect">
            <a:avLst/>
          </a:prstGeom>
        </p:spPr>
      </p:pic>
      <p:grpSp>
        <p:nvGrpSpPr>
          <p:cNvPr id="6" name="Gruppieren 5"/>
          <p:cNvGrpSpPr/>
          <p:nvPr/>
        </p:nvGrpSpPr>
        <p:grpSpPr>
          <a:xfrm>
            <a:off x="3840609" y="2337471"/>
            <a:ext cx="1539898" cy="983623"/>
            <a:chOff x="3592959" y="2975646"/>
            <a:chExt cx="1539898" cy="983623"/>
          </a:xfrm>
        </p:grpSpPr>
        <p:sp>
          <p:nvSpPr>
            <p:cNvPr id="3" name="Rechteck 2"/>
            <p:cNvSpPr/>
            <p:nvPr/>
          </p:nvSpPr>
          <p:spPr>
            <a:xfrm>
              <a:off x="4487537" y="3005502"/>
              <a:ext cx="467847" cy="2441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4411797" y="2975646"/>
              <a:ext cx="63190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ineocytoma</a:t>
              </a: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4411797" y="3081872"/>
              <a:ext cx="6607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urrent cohort</a:t>
              </a:r>
            </a:p>
          </p:txBody>
        </p:sp>
        <p:sp>
          <p:nvSpPr>
            <p:cNvPr id="4" name="Rechteck 3"/>
            <p:cNvSpPr/>
            <p:nvPr/>
          </p:nvSpPr>
          <p:spPr>
            <a:xfrm>
              <a:off x="3700905" y="3005502"/>
              <a:ext cx="611559" cy="95376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3593426" y="3539421"/>
              <a:ext cx="76655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B-RB1 (tril. RB)</a:t>
              </a:r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3595255" y="2977078"/>
              <a:ext cx="65274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B-miRNA1A</a:t>
              </a:r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3595255" y="3098531"/>
              <a:ext cx="65274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B-miRNA1B</a:t>
              </a:r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3594480" y="3206393"/>
              <a:ext cx="60144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B-miRNA2</a:t>
              </a:r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3596166" y="3313422"/>
              <a:ext cx="76174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B-MYC/FOXR2</a:t>
              </a:r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3595255" y="3423859"/>
              <a:ext cx="46358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B-RB1</a:t>
              </a:r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3592959" y="3644292"/>
              <a:ext cx="48763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PTID-A</a:t>
              </a:r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3596769" y="3754324"/>
              <a:ext cx="48763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PTID-B</a:t>
              </a:r>
            </a:p>
          </p:txBody>
        </p:sp>
        <p:sp>
          <p:nvSpPr>
            <p:cNvPr id="5" name="Rechteck 4"/>
            <p:cNvSpPr/>
            <p:nvPr/>
          </p:nvSpPr>
          <p:spPr>
            <a:xfrm>
              <a:off x="4487537" y="3348139"/>
              <a:ext cx="467847" cy="58350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9" name="Textfeld 28"/>
            <p:cNvSpPr txBox="1"/>
            <p:nvPr/>
          </p:nvSpPr>
          <p:spPr>
            <a:xfrm>
              <a:off x="4406842" y="3526571"/>
              <a:ext cx="59503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IN_T_PPT</a:t>
              </a:r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4409582" y="3318932"/>
              <a:ext cx="72327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tinoblastoma</a:t>
              </a:r>
            </a:p>
          </p:txBody>
        </p:sp>
        <p:sp>
          <p:nvSpPr>
            <p:cNvPr id="31" name="Textfeld 30"/>
            <p:cNvSpPr txBox="1"/>
            <p:nvPr/>
          </p:nvSpPr>
          <p:spPr>
            <a:xfrm>
              <a:off x="4408671" y="3422025"/>
              <a:ext cx="55816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RL_PIN</a:t>
              </a:r>
            </a:p>
          </p:txBody>
        </p:sp>
        <p:sp>
          <p:nvSpPr>
            <p:cNvPr id="32" name="Textfeld 31"/>
            <p:cNvSpPr txBox="1"/>
            <p:nvPr/>
          </p:nvSpPr>
          <p:spPr>
            <a:xfrm>
              <a:off x="4406375" y="3638786"/>
              <a:ext cx="6431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IN_T_PB_A</a:t>
              </a:r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4410185" y="3752490"/>
              <a:ext cx="6431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IN_T_PB_B</a:t>
              </a:r>
            </a:p>
          </p:txBody>
        </p:sp>
      </p:grpSp>
      <p:grpSp>
        <p:nvGrpSpPr>
          <p:cNvPr id="47" name="Gruppieren 46"/>
          <p:cNvGrpSpPr/>
          <p:nvPr/>
        </p:nvGrpSpPr>
        <p:grpSpPr>
          <a:xfrm>
            <a:off x="6166623" y="273053"/>
            <a:ext cx="2808472" cy="2608192"/>
            <a:chOff x="5900739" y="885101"/>
            <a:chExt cx="2808472" cy="2608192"/>
          </a:xfrm>
        </p:grpSpPr>
        <p:pic>
          <p:nvPicPr>
            <p:cNvPr id="103" name="Grafik 10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900739" y="885101"/>
              <a:ext cx="2808472" cy="2608192"/>
            </a:xfrm>
            <a:prstGeom prst="rect">
              <a:avLst/>
            </a:prstGeom>
          </p:spPr>
        </p:pic>
        <p:sp>
          <p:nvSpPr>
            <p:cNvPr id="35" name="Rechteck 34"/>
            <p:cNvSpPr/>
            <p:nvPr/>
          </p:nvSpPr>
          <p:spPr>
            <a:xfrm>
              <a:off x="8021782" y="2552006"/>
              <a:ext cx="586047" cy="71011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34" name="Gruppieren 33"/>
          <p:cNvGrpSpPr/>
          <p:nvPr/>
        </p:nvGrpSpPr>
        <p:grpSpPr>
          <a:xfrm>
            <a:off x="8164401" y="1578052"/>
            <a:ext cx="767024" cy="1064586"/>
            <a:chOff x="8796283" y="1354674"/>
            <a:chExt cx="767024" cy="1064586"/>
          </a:xfrm>
        </p:grpSpPr>
        <p:sp>
          <p:nvSpPr>
            <p:cNvPr id="36" name="Textfeld 35"/>
            <p:cNvSpPr txBox="1"/>
            <p:nvPr/>
          </p:nvSpPr>
          <p:spPr>
            <a:xfrm>
              <a:off x="8803546" y="2234594"/>
              <a:ext cx="63190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ineocytoma</a:t>
              </a:r>
            </a:p>
          </p:txBody>
        </p:sp>
        <p:sp>
          <p:nvSpPr>
            <p:cNvPr id="38" name="Textfeld 37"/>
            <p:cNvSpPr txBox="1"/>
            <p:nvPr/>
          </p:nvSpPr>
          <p:spPr>
            <a:xfrm>
              <a:off x="8796750" y="1917017"/>
              <a:ext cx="76655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B-RB1 (tril. RB)</a:t>
              </a:r>
            </a:p>
          </p:txBody>
        </p:sp>
        <p:sp>
          <p:nvSpPr>
            <p:cNvPr id="39" name="Textfeld 38"/>
            <p:cNvSpPr txBox="1"/>
            <p:nvPr/>
          </p:nvSpPr>
          <p:spPr>
            <a:xfrm>
              <a:off x="8798579" y="1354674"/>
              <a:ext cx="65274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B-miRNA1A</a:t>
              </a:r>
            </a:p>
          </p:txBody>
        </p:sp>
        <p:sp>
          <p:nvSpPr>
            <p:cNvPr id="40" name="Textfeld 39"/>
            <p:cNvSpPr txBox="1"/>
            <p:nvPr/>
          </p:nvSpPr>
          <p:spPr>
            <a:xfrm>
              <a:off x="8798579" y="1476127"/>
              <a:ext cx="65274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B-miRNA1B</a:t>
              </a:r>
            </a:p>
          </p:txBody>
        </p:sp>
        <p:sp>
          <p:nvSpPr>
            <p:cNvPr id="41" name="Textfeld 40"/>
            <p:cNvSpPr txBox="1"/>
            <p:nvPr/>
          </p:nvSpPr>
          <p:spPr>
            <a:xfrm>
              <a:off x="8797804" y="1583989"/>
              <a:ext cx="60144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B-miRNA2</a:t>
              </a:r>
            </a:p>
          </p:txBody>
        </p:sp>
        <p:sp>
          <p:nvSpPr>
            <p:cNvPr id="42" name="Textfeld 41"/>
            <p:cNvSpPr txBox="1"/>
            <p:nvPr/>
          </p:nvSpPr>
          <p:spPr>
            <a:xfrm>
              <a:off x="8799490" y="1691018"/>
              <a:ext cx="76174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B-MYC/FOXR2</a:t>
              </a:r>
            </a:p>
          </p:txBody>
        </p:sp>
        <p:sp>
          <p:nvSpPr>
            <p:cNvPr id="43" name="Textfeld 42"/>
            <p:cNvSpPr txBox="1"/>
            <p:nvPr/>
          </p:nvSpPr>
          <p:spPr>
            <a:xfrm>
              <a:off x="8798579" y="1801455"/>
              <a:ext cx="46358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B-RB1</a:t>
              </a:r>
            </a:p>
          </p:txBody>
        </p:sp>
        <p:sp>
          <p:nvSpPr>
            <p:cNvPr id="44" name="Textfeld 43"/>
            <p:cNvSpPr txBox="1"/>
            <p:nvPr/>
          </p:nvSpPr>
          <p:spPr>
            <a:xfrm>
              <a:off x="8796283" y="2021888"/>
              <a:ext cx="48763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PTID-A</a:t>
              </a:r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8800093" y="2131920"/>
              <a:ext cx="48763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PTID-B</a:t>
              </a:r>
            </a:p>
          </p:txBody>
        </p:sp>
        <p:pic>
          <p:nvPicPr>
            <p:cNvPr id="46" name="Grafik 45"/>
            <p:cNvPicPr>
              <a:picLocks noChangeAspect="1"/>
            </p:cNvPicPr>
            <p:nvPr/>
          </p:nvPicPr>
          <p:blipFill rotWithShape="1">
            <a:blip r:embed="rId4"/>
            <a:srcRect l="76652" t="64741" r="21938" b="9719"/>
            <a:stretch/>
          </p:blipFill>
          <p:spPr>
            <a:xfrm>
              <a:off x="8819804" y="1423252"/>
              <a:ext cx="55747" cy="937564"/>
            </a:xfrm>
            <a:prstGeom prst="rect">
              <a:avLst/>
            </a:prstGeom>
          </p:spPr>
        </p:pic>
        <p:sp>
          <p:nvSpPr>
            <p:cNvPr id="28" name="Rechteck 27"/>
            <p:cNvSpPr/>
            <p:nvPr/>
          </p:nvSpPr>
          <p:spPr>
            <a:xfrm>
              <a:off x="8796283" y="1354674"/>
              <a:ext cx="705164" cy="1064586"/>
            </a:xfrm>
            <a:prstGeom prst="rect">
              <a:avLst/>
            </a:prstGeom>
            <a:noFill/>
            <a:ln w="952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48" name="Textfeld 47"/>
          <p:cNvSpPr txBox="1"/>
          <p:nvPr/>
        </p:nvSpPr>
        <p:spPr>
          <a:xfrm>
            <a:off x="351734" y="421232"/>
            <a:ext cx="282450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5908611" y="421232"/>
            <a:ext cx="303288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3285353" y="3498563"/>
            <a:ext cx="271228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96715" y="5173477"/>
            <a:ext cx="7508631" cy="156966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de-DE" sz="16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Supplementary Figure 2:</a:t>
            </a:r>
          </a:p>
          <a:p>
            <a:pPr algn="just"/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(a) t-SNE plot of 104 samples </a:t>
            </a:r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from </a:t>
            </a:r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the current </a:t>
            </a:r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cohort</a:t>
            </a:r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(the two </a:t>
            </a:r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pineal anlage tumors and the </a:t>
            </a:r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WNT-activated pineoblastoma </a:t>
            </a:r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were omitted</a:t>
            </a:r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) </a:t>
            </a:r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together with a </a:t>
            </a:r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combined </a:t>
            </a:r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CNS tumor reference cohort from Capper et al</a:t>
            </a:r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and the </a:t>
            </a:r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consensus cohort </a:t>
            </a:r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from Liu et al</a:t>
            </a:r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(n = 2,976 </a:t>
            </a:r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together; an overlap of 5 cases from the current cohort and the Liu cohort exists). (b) t-SNE plot of 104 samples and (c) UMAP plot of all 83 pineoblastoma (PB) samples.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61298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00788" y="6385224"/>
            <a:ext cx="1102601" cy="175777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02522" y="6385225"/>
            <a:ext cx="1840262" cy="157532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9923644" y="676215"/>
            <a:ext cx="1954032" cy="5755422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de-DE" sz="16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Supplementary Figure 3:</a:t>
            </a:r>
          </a:p>
          <a:p>
            <a:pPr algn="just"/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Detailed overview of the 67 miRNA-altered pineo-blastoma subtypes (PB-miRNA1A, n=40; PB-miRNA1B, n=8; PB-miRNA2, n=19).</a:t>
            </a:r>
          </a:p>
          <a:p>
            <a:pPr algn="just"/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Missing data are shown in </a:t>
            </a:r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grey.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/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Abbreviations: </a:t>
            </a:r>
          </a:p>
          <a:p>
            <a:pPr algn="just"/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mut., mutation; </a:t>
            </a:r>
          </a:p>
          <a:p>
            <a:pPr algn="just"/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Chr., chromosome; LOH, loss of hetero-</a:t>
            </a:r>
            <a:r>
              <a:rPr lang="de-DE" sz="1600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zygosity</a:t>
            </a:r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 (orange background); m, mosaic; </a:t>
            </a:r>
            <a:r>
              <a:rPr lang="de-DE" sz="1600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cn</a:t>
            </a:r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, copy-neutral; </a:t>
            </a:r>
            <a:r>
              <a:rPr lang="de-DE" sz="1600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cg</a:t>
            </a:r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, copy gain; y., years; PFS, progression-free survival; OS, overall survival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6000" y="489601"/>
            <a:ext cx="9434007" cy="591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05461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/>
          <p:cNvSpPr txBox="1"/>
          <p:nvPr/>
        </p:nvSpPr>
        <p:spPr>
          <a:xfrm>
            <a:off x="485233" y="3227096"/>
            <a:ext cx="292068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d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3"/>
          <a:srcRect t="19346" b="23668"/>
          <a:stretch/>
        </p:blipFill>
        <p:spPr>
          <a:xfrm>
            <a:off x="973959" y="3231085"/>
            <a:ext cx="9715566" cy="1540800"/>
          </a:xfrm>
          <a:prstGeom prst="rect">
            <a:avLst/>
          </a:prstGeom>
        </p:spPr>
      </p:pic>
      <p:pic>
        <p:nvPicPr>
          <p:cNvPr id="6" name="Picture 8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79" t="19050" r="26878" b="45379"/>
          <a:stretch/>
        </p:blipFill>
        <p:spPr bwMode="auto">
          <a:xfrm>
            <a:off x="468000" y="306093"/>
            <a:ext cx="3511496" cy="165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9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61" t="17058" r="26756" b="47575"/>
          <a:stretch/>
        </p:blipFill>
        <p:spPr bwMode="auto">
          <a:xfrm>
            <a:off x="4202278" y="306093"/>
            <a:ext cx="3519866" cy="165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10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87" t="16710" r="26745" b="47671"/>
          <a:stretch/>
        </p:blipFill>
        <p:spPr bwMode="auto">
          <a:xfrm>
            <a:off x="7963275" y="306093"/>
            <a:ext cx="3501457" cy="165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feld 10"/>
          <p:cNvSpPr txBox="1"/>
          <p:nvPr/>
        </p:nvSpPr>
        <p:spPr>
          <a:xfrm>
            <a:off x="440991" y="123510"/>
            <a:ext cx="282450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4168245" y="123510"/>
            <a:ext cx="303288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7917114" y="152937"/>
            <a:ext cx="271228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748214" y="2024932"/>
            <a:ext cx="2298386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Subtype PB-miRNA1A</a:t>
            </a:r>
          </a:p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female, 16 years</a:t>
            </a:r>
          </a:p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polyploid genome</a:t>
            </a:r>
          </a:p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M0</a:t>
            </a:r>
          </a:p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no relapse/progression; alive</a:t>
            </a:r>
            <a:endParaRPr lang="de-DE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4505336" y="2027204"/>
            <a:ext cx="2298386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Subtype PB-miRNA1A</a:t>
            </a:r>
          </a:p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female, 11 years</a:t>
            </a:r>
          </a:p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polyploid genome</a:t>
            </a:r>
          </a:p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M0</a:t>
            </a:r>
          </a:p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no relapse/progression; alive</a:t>
            </a:r>
            <a:endParaRPr lang="de-DE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8267579" y="2022652"/>
            <a:ext cx="1945276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Subtype PB-miRNA1A</a:t>
            </a:r>
          </a:p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female, 17 years</a:t>
            </a:r>
          </a:p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non-polyploid genome</a:t>
            </a:r>
          </a:p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M-status unknown</a:t>
            </a:r>
          </a:p>
          <a:p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s</a:t>
            </a:r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urvival status unknown</a:t>
            </a:r>
            <a:endParaRPr lang="de-DE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493935" y="4944264"/>
            <a:ext cx="11245220" cy="1815882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de-DE" sz="16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Supplementary Figure 4:</a:t>
            </a:r>
          </a:p>
          <a:p>
            <a:pPr algn="just"/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(a-c) Copy number profiles of the </a:t>
            </a:r>
            <a:r>
              <a:rPr lang="de-DE" sz="1600" i="1" dirty="0" smtClean="0">
                <a:latin typeface="Calibri" panose="020F0502020204030204" pitchFamily="34" charset="0"/>
                <a:cs typeface="Calibri" panose="020F0502020204030204" pitchFamily="34" charset="0"/>
              </a:rPr>
              <a:t>DROSHA</a:t>
            </a:r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 gene locus on chromosomal region 5p13.3 from next-generation sequencing data from three tumor samples showing breakpoints within the </a:t>
            </a:r>
            <a:r>
              <a:rPr lang="de-DE" sz="1600" i="1" dirty="0" smtClean="0">
                <a:latin typeface="Calibri" panose="020F0502020204030204" pitchFamily="34" charset="0"/>
                <a:cs typeface="Calibri" panose="020F0502020204030204" pitchFamily="34" charset="0"/>
              </a:rPr>
              <a:t>DROSHA</a:t>
            </a:r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 gene. </a:t>
            </a:r>
          </a:p>
          <a:p>
            <a:pPr algn="just"/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(d) 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GISTIC plots (Q-</a:t>
            </a:r>
            <a:r>
              <a:rPr lang="de-DE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Bound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 cut-off: </a:t>
            </a:r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0.005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) of </a:t>
            </a:r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miRNA-altered PB samples (N=67). 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Significant GISTIC regions are shown in darker grey within </a:t>
            </a:r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extended GISTIC 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regions (light grey). Often GISTIC regions and extended regions are equal (only dark grey). </a:t>
            </a:r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The blue arrow indicates the </a:t>
            </a:r>
            <a:r>
              <a:rPr lang="de-DE" sz="1600" i="1" dirty="0" smtClean="0">
                <a:latin typeface="Calibri" panose="020F0502020204030204" pitchFamily="34" charset="0"/>
                <a:cs typeface="Calibri" panose="020F0502020204030204" pitchFamily="34" charset="0"/>
              </a:rPr>
              <a:t>OTX2</a:t>
            </a:r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 locus, red array the </a:t>
            </a:r>
            <a:r>
              <a:rPr lang="de-DE" sz="1600" i="1" dirty="0" smtClean="0">
                <a:latin typeface="Calibri" panose="020F0502020204030204" pitchFamily="34" charset="0"/>
                <a:cs typeface="Calibri" panose="020F0502020204030204" pitchFamily="34" charset="0"/>
              </a:rPr>
              <a:t>DROSHA</a:t>
            </a:r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 locus. Most other significant regions are copy-number variations frequently present in the general population.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9" name="Gerade Verbindung mit Pfeil 18">
            <a:extLst>
              <a:ext uri="{FF2B5EF4-FFF2-40B4-BE49-F238E27FC236}">
                <a16:creationId xmlns:a16="http://schemas.microsoft.com/office/drawing/2014/main" id="{4C7DBA8F-6694-6A1C-EADC-737BCFBB1872}"/>
              </a:ext>
            </a:extLst>
          </p:cNvPr>
          <p:cNvCxnSpPr/>
          <p:nvPr/>
        </p:nvCxnSpPr>
        <p:spPr>
          <a:xfrm>
            <a:off x="8634214" y="3565377"/>
            <a:ext cx="0" cy="216000"/>
          </a:xfrm>
          <a:prstGeom prst="straightConnector1">
            <a:avLst/>
          </a:prstGeom>
          <a:ln w="38100">
            <a:solidFill>
              <a:srgbClr val="460CEA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 Verbindung mit Pfeil 19">
            <a:extLst>
              <a:ext uri="{FF2B5EF4-FFF2-40B4-BE49-F238E27FC236}">
                <a16:creationId xmlns:a16="http://schemas.microsoft.com/office/drawing/2014/main" id="{4C7DBA8F-6694-6A1C-EADC-737BCFBB1872}"/>
              </a:ext>
            </a:extLst>
          </p:cNvPr>
          <p:cNvCxnSpPr/>
          <p:nvPr/>
        </p:nvCxnSpPr>
        <p:spPr>
          <a:xfrm flipV="1">
            <a:off x="4202278" y="4680858"/>
            <a:ext cx="1" cy="21600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810343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5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93" t="13659" r="26236" b="34231"/>
          <a:stretch/>
        </p:blipFill>
        <p:spPr bwMode="auto">
          <a:xfrm>
            <a:off x="648000" y="701400"/>
            <a:ext cx="3456000" cy="237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6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76" t="16831" r="26548" b="31303"/>
          <a:stretch/>
        </p:blipFill>
        <p:spPr bwMode="auto">
          <a:xfrm>
            <a:off x="4356000" y="701400"/>
            <a:ext cx="3420000" cy="234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7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89" t="16902" r="26770" b="31415"/>
          <a:stretch/>
        </p:blipFill>
        <p:spPr bwMode="auto">
          <a:xfrm>
            <a:off x="8010000" y="701400"/>
            <a:ext cx="3348000" cy="230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feld 5"/>
          <p:cNvSpPr txBox="1"/>
          <p:nvPr/>
        </p:nvSpPr>
        <p:spPr>
          <a:xfrm>
            <a:off x="593397" y="519840"/>
            <a:ext cx="282450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4301601" y="485972"/>
            <a:ext cx="303288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7947799" y="515399"/>
            <a:ext cx="271228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964872" y="3126841"/>
            <a:ext cx="3218060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Subtype PB-miRNA1A</a:t>
            </a:r>
          </a:p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female, 16 years</a:t>
            </a:r>
          </a:p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polyploid genome</a:t>
            </a:r>
          </a:p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breakpoint within </a:t>
            </a:r>
            <a:r>
              <a:rPr lang="de-DE" i="1" dirty="0" smtClean="0">
                <a:latin typeface="Calibri" panose="020F0502020204030204" pitchFamily="34" charset="0"/>
                <a:cs typeface="Calibri" panose="020F0502020204030204" pitchFamily="34" charset="0"/>
              </a:rPr>
              <a:t>DROSHA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 gene</a:t>
            </a:r>
          </a:p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M0</a:t>
            </a:r>
          </a:p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no relapse/progression; alive</a:t>
            </a:r>
            <a:endParaRPr lang="de-DE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4659743" y="3126841"/>
            <a:ext cx="3326616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Subtype PB-miRNA1A</a:t>
            </a:r>
          </a:p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female, 15 years</a:t>
            </a:r>
          </a:p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non-polyploid genome</a:t>
            </a:r>
          </a:p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two truncating </a:t>
            </a:r>
            <a:r>
              <a:rPr lang="de-DE" i="1" dirty="0" smtClean="0">
                <a:latin typeface="Calibri" panose="020F0502020204030204" pitchFamily="34" charset="0"/>
                <a:cs typeface="Calibri" panose="020F0502020204030204" pitchFamily="34" charset="0"/>
              </a:rPr>
              <a:t>DICER1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 mutations</a:t>
            </a:r>
          </a:p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M+</a:t>
            </a:r>
          </a:p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relapse/progression; dead</a:t>
            </a:r>
            <a:endParaRPr lang="de-DE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8315500" y="3131761"/>
            <a:ext cx="3706207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Subtype PB-miRNA2</a:t>
            </a:r>
          </a:p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male, 17 years</a:t>
            </a:r>
          </a:p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non-polyploid genome</a:t>
            </a:r>
          </a:p>
          <a:p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artial homozygous </a:t>
            </a:r>
            <a:r>
              <a:rPr lang="de-DE" i="1" dirty="0" smtClean="0">
                <a:latin typeface="Calibri" panose="020F0502020204030204" pitchFamily="34" charset="0"/>
                <a:cs typeface="Calibri" panose="020F0502020204030204" pitchFamily="34" charset="0"/>
              </a:rPr>
              <a:t>DROSHA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 deletion</a:t>
            </a:r>
          </a:p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M+</a:t>
            </a:r>
          </a:p>
          <a:p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no relapse/progression; alive</a:t>
            </a:r>
            <a:endParaRPr lang="de-DE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493935" y="5058564"/>
            <a:ext cx="11245220" cy="830997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de-DE" sz="16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Supplementary Figure 5:</a:t>
            </a:r>
          </a:p>
          <a:p>
            <a:pPr algn="just"/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Copy number profiles (upper part) and allele ratio (lower part) of whole chromosomes 5 (a), 10 (b), and 15 (c) from molecular inversion probe (MIP) array from three tumor samples showing chromothryptic like genomic aberrations.</a:t>
            </a:r>
          </a:p>
        </p:txBody>
      </p:sp>
    </p:spTree>
    <p:extLst>
      <p:ext uri="{BB962C8B-B14F-4D97-AF65-F5344CB8AC3E}">
        <p14:creationId xmlns:p14="http://schemas.microsoft.com/office/powerpoint/2010/main" val="9293538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5627289" y="246793"/>
            <a:ext cx="5957677" cy="2099186"/>
            <a:chOff x="669302" y="877930"/>
            <a:chExt cx="10591173" cy="4094762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" t="-7" r="858" b="48660"/>
            <a:stretch/>
          </p:blipFill>
          <p:spPr>
            <a:xfrm>
              <a:off x="669302" y="877930"/>
              <a:ext cx="10591173" cy="4094762"/>
            </a:xfrm>
            <a:prstGeom prst="rect">
              <a:avLst/>
            </a:prstGeom>
          </p:spPr>
        </p:pic>
        <p:sp>
          <p:nvSpPr>
            <p:cNvPr id="4" name="Rechteck 3"/>
            <p:cNvSpPr/>
            <p:nvPr/>
          </p:nvSpPr>
          <p:spPr>
            <a:xfrm>
              <a:off x="673761" y="2989780"/>
              <a:ext cx="462336" cy="197263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6" name="Textfeld 5"/>
          <p:cNvSpPr txBox="1"/>
          <p:nvPr/>
        </p:nvSpPr>
        <p:spPr>
          <a:xfrm>
            <a:off x="241962" y="189642"/>
            <a:ext cx="282450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5408214" y="246792"/>
            <a:ext cx="303288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11" name="Gruppieren 10"/>
          <p:cNvGrpSpPr/>
          <p:nvPr/>
        </p:nvGrpSpPr>
        <p:grpSpPr>
          <a:xfrm>
            <a:off x="5540753" y="2551251"/>
            <a:ext cx="6041648" cy="2065664"/>
            <a:chOff x="5674102" y="3503750"/>
            <a:chExt cx="6226325" cy="2251033"/>
          </a:xfrm>
        </p:grpSpPr>
        <p:pic>
          <p:nvPicPr>
            <p:cNvPr id="9" name="Grafik 8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4" r="972" b="49218"/>
            <a:stretch/>
          </p:blipFill>
          <p:spPr>
            <a:xfrm>
              <a:off x="5674914" y="3503750"/>
              <a:ext cx="6225513" cy="2251033"/>
            </a:xfrm>
            <a:prstGeom prst="rect">
              <a:avLst/>
            </a:prstGeom>
          </p:spPr>
        </p:pic>
        <p:sp>
          <p:nvSpPr>
            <p:cNvPr id="10" name="Rechteck 9"/>
            <p:cNvSpPr/>
            <p:nvPr/>
          </p:nvSpPr>
          <p:spPr>
            <a:xfrm>
              <a:off x="5674102" y="4693523"/>
              <a:ext cx="268020" cy="105121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12" name="Textfeld 11"/>
          <p:cNvSpPr txBox="1"/>
          <p:nvPr/>
        </p:nvSpPr>
        <p:spPr>
          <a:xfrm>
            <a:off x="5409893" y="2524527"/>
            <a:ext cx="271228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7751972" y="4564503"/>
            <a:ext cx="4299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Calibri" panose="020F0502020204030204" pitchFamily="34" charset="0"/>
                <a:cs typeface="Calibri" panose="020F0502020204030204" pitchFamily="34" charset="0"/>
              </a:rPr>
              <a:t>RB1</a:t>
            </a:r>
            <a:endParaRPr lang="de-DE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9987254" y="4564497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Calibri" panose="020F0502020204030204" pitchFamily="34" charset="0"/>
                <a:cs typeface="Calibri" panose="020F0502020204030204" pitchFamily="34" charset="0"/>
              </a:rPr>
              <a:t>miR17/92</a:t>
            </a:r>
            <a:endParaRPr lang="de-DE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8602991" y="2257050"/>
            <a:ext cx="4299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Calibri" panose="020F0502020204030204" pitchFamily="34" charset="0"/>
                <a:cs typeface="Calibri" panose="020F0502020204030204" pitchFamily="34" charset="0"/>
              </a:rPr>
              <a:t>RB1</a:t>
            </a:r>
            <a:endParaRPr lang="de-DE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4" name="Grafik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62484" y="4714403"/>
            <a:ext cx="5619917" cy="857543"/>
          </a:xfrm>
          <a:prstGeom prst="rect">
            <a:avLst/>
          </a:prstGeom>
        </p:spPr>
      </p:pic>
      <p:sp>
        <p:nvSpPr>
          <p:cNvPr id="27" name="Textfeld 26"/>
          <p:cNvSpPr txBox="1"/>
          <p:nvPr/>
        </p:nvSpPr>
        <p:spPr>
          <a:xfrm>
            <a:off x="5419418" y="4915302"/>
            <a:ext cx="292068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d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236760" y="5706264"/>
            <a:ext cx="11726640" cy="107721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de-DE" sz="16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Supplementary Figure 6:</a:t>
            </a:r>
          </a:p>
          <a:p>
            <a:pPr algn="just"/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(a) Detailed 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overview of </a:t>
            </a:r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pineoblastoma 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subtypes </a:t>
            </a:r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PB-MYC/FOXR2 and PB-RB1 (n=8 each). </a:t>
            </a:r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Missing </a:t>
            </a:r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data are shown in grey</a:t>
            </a:r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. For abbreviations see Supplementary Figure 3. (b and c) Copy number plots from MIP array of the </a:t>
            </a:r>
            <a:r>
              <a:rPr lang="en-US" sz="1600" i="1" dirty="0" smtClean="0">
                <a:latin typeface="Calibri" panose="020F0502020204030204" pitchFamily="34" charset="0"/>
                <a:cs typeface="Calibri" panose="020F0502020204030204" pitchFamily="34" charset="0"/>
              </a:rPr>
              <a:t>RB1</a:t>
            </a:r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 gene locus (b) and chromosome arm 13q (c) of the 8 PB-RB1 samples. A detailed copy-number plot of the </a:t>
            </a:r>
            <a:r>
              <a:rPr lang="en-US" sz="1600" i="1" dirty="0" smtClean="0">
                <a:latin typeface="Calibri" panose="020F0502020204030204" pitchFamily="34" charset="0"/>
                <a:cs typeface="Calibri" panose="020F0502020204030204" pitchFamily="34" charset="0"/>
              </a:rPr>
              <a:t>RB1</a:t>
            </a:r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 locus of the uppermost case is shown in Figure 3f. (d) Overview of </a:t>
            </a:r>
            <a:r>
              <a:rPr lang="en-US" sz="1600" i="1" dirty="0" smtClean="0">
                <a:latin typeface="Calibri" panose="020F0502020204030204" pitchFamily="34" charset="0"/>
                <a:cs typeface="Calibri" panose="020F0502020204030204" pitchFamily="34" charset="0"/>
              </a:rPr>
              <a:t>RB1</a:t>
            </a:r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 variants.</a:t>
            </a:r>
            <a:endParaRPr lang="de-DE" sz="1600" dirty="0" smtClean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1999" y="187200"/>
            <a:ext cx="4337832" cy="545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274887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ieren 40"/>
          <p:cNvGrpSpPr/>
          <p:nvPr/>
        </p:nvGrpSpPr>
        <p:grpSpPr>
          <a:xfrm>
            <a:off x="6401013" y="488332"/>
            <a:ext cx="4581525" cy="3717240"/>
            <a:chOff x="3958647" y="807919"/>
            <a:chExt cx="3610342" cy="3200924"/>
          </a:xfrm>
        </p:grpSpPr>
        <p:pic>
          <p:nvPicPr>
            <p:cNvPr id="37" name="Grafik 3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58647" y="807919"/>
              <a:ext cx="3610342" cy="3151762"/>
            </a:xfrm>
            <a:prstGeom prst="rect">
              <a:avLst/>
            </a:prstGeom>
          </p:spPr>
        </p:pic>
        <p:sp>
          <p:nvSpPr>
            <p:cNvPr id="38" name="Rechteck 37"/>
            <p:cNvSpPr/>
            <p:nvPr/>
          </p:nvSpPr>
          <p:spPr>
            <a:xfrm>
              <a:off x="4036471" y="3853199"/>
              <a:ext cx="651753" cy="1556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pic>
        <p:nvPicPr>
          <p:cNvPr id="36" name="Grafik 3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926" y="488332"/>
            <a:ext cx="4680187" cy="3661114"/>
          </a:xfrm>
          <a:prstGeom prst="rect">
            <a:avLst/>
          </a:prstGeom>
        </p:spPr>
      </p:pic>
      <p:sp>
        <p:nvSpPr>
          <p:cNvPr id="39" name="Rechteck 38"/>
          <p:cNvSpPr/>
          <p:nvPr/>
        </p:nvSpPr>
        <p:spPr>
          <a:xfrm>
            <a:off x="407379" y="4056744"/>
            <a:ext cx="5233025" cy="13612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 smtClean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    PAT 1: male; 0.9 years; M-status unknown; relapse/dead </a:t>
            </a:r>
            <a:endParaRPr lang="de-DE" sz="1600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4789064" y="140050"/>
            <a:ext cx="26255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Pinealanlagetumors (PAT)</a:t>
            </a:r>
            <a:endParaRPr lang="de-DE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3306174" y="5845760"/>
            <a:ext cx="55906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No pathogenic or likely pathogenic variants in both PAT detected.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47" name="Grafik 4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56937" y="4351222"/>
            <a:ext cx="4695691" cy="14501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8" name="Grafik 4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35776" y="4349487"/>
            <a:ext cx="4748546" cy="145621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0" name="Textfeld 49"/>
          <p:cNvSpPr txBox="1"/>
          <p:nvPr/>
        </p:nvSpPr>
        <p:spPr>
          <a:xfrm rot="16200000">
            <a:off x="10407113" y="1354256"/>
            <a:ext cx="13089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Copy number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 rot="16200000">
            <a:off x="10530985" y="3163861"/>
            <a:ext cx="10826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Allele ratio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" name="Rechteck 20"/>
          <p:cNvSpPr/>
          <p:nvPr/>
        </p:nvSpPr>
        <p:spPr>
          <a:xfrm>
            <a:off x="6641531" y="4049792"/>
            <a:ext cx="3850464" cy="15170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 smtClean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AT 2: female; 0.5 years; no clinical data </a:t>
            </a:r>
            <a:endParaRPr lang="de-DE" sz="1600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735777" y="6298807"/>
            <a:ext cx="10752589" cy="33855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de-DE" sz="16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Supplementary Figure 7: </a:t>
            </a:r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Detailed overview of the two pineal anlage tumors (PAT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.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 rot="16200000">
            <a:off x="4450516" y="1351008"/>
            <a:ext cx="13089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Copy number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 rot="16200000">
            <a:off x="4574388" y="3180069"/>
            <a:ext cx="10826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Allele ratio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9924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410932" y="6162615"/>
            <a:ext cx="11297555" cy="58477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de-DE" sz="16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Supplementary Figure 8:</a:t>
            </a:r>
          </a:p>
          <a:p>
            <a:pPr algn="just"/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Detailed overview of the WNT-activated PB (ectopic WNT-medulloblastoma).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54442" y="591526"/>
            <a:ext cx="5640904" cy="1980318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13" name="Gruppieren 12"/>
          <p:cNvGrpSpPr/>
          <p:nvPr/>
        </p:nvGrpSpPr>
        <p:grpSpPr>
          <a:xfrm>
            <a:off x="233460" y="291877"/>
            <a:ext cx="5785424" cy="4536545"/>
            <a:chOff x="496108" y="408613"/>
            <a:chExt cx="5785424" cy="4536545"/>
          </a:xfrm>
        </p:grpSpPr>
        <p:grpSp>
          <p:nvGrpSpPr>
            <p:cNvPr id="3" name="Gruppieren 2"/>
            <p:cNvGrpSpPr/>
            <p:nvPr/>
          </p:nvGrpSpPr>
          <p:grpSpPr>
            <a:xfrm>
              <a:off x="496108" y="408613"/>
              <a:ext cx="5599891" cy="4536545"/>
              <a:chOff x="7908588" y="652800"/>
              <a:chExt cx="3642572" cy="3218812"/>
            </a:xfrm>
          </p:grpSpPr>
          <p:pic>
            <p:nvPicPr>
              <p:cNvPr id="4" name="Grafik 3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908588" y="652800"/>
                <a:ext cx="3642572" cy="3179899"/>
              </a:xfrm>
              <a:prstGeom prst="rect">
                <a:avLst/>
              </a:prstGeom>
            </p:spPr>
          </p:pic>
          <p:sp>
            <p:nvSpPr>
              <p:cNvPr id="5" name="Rechteck 4"/>
              <p:cNvSpPr/>
              <p:nvPr/>
            </p:nvSpPr>
            <p:spPr>
              <a:xfrm>
                <a:off x="7976680" y="3715968"/>
                <a:ext cx="651753" cy="15564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</p:grpSp>
        <p:sp>
          <p:nvSpPr>
            <p:cNvPr id="8" name="Textfeld 7"/>
            <p:cNvSpPr txBox="1"/>
            <p:nvPr/>
          </p:nvSpPr>
          <p:spPr>
            <a:xfrm rot="16200000">
              <a:off x="5441526" y="1509887"/>
              <a:ext cx="130894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Copy number</a:t>
              </a:r>
              <a:endParaRPr lang="de-DE" sz="1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" name="Textfeld 8"/>
            <p:cNvSpPr txBox="1"/>
            <p:nvPr/>
          </p:nvSpPr>
          <p:spPr>
            <a:xfrm rot="16200000">
              <a:off x="5570953" y="3717869"/>
              <a:ext cx="108260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Allele ratio</a:t>
              </a:r>
              <a:endParaRPr lang="de-DE" sz="1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10" name="Rechteck 9"/>
          <p:cNvSpPr/>
          <p:nvPr/>
        </p:nvSpPr>
        <p:spPr>
          <a:xfrm>
            <a:off x="6048065" y="2746943"/>
            <a:ext cx="5187381" cy="28808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 smtClean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WNT-activated PB: male; 12 years; M0; no relapse/alive </a:t>
            </a:r>
            <a:endParaRPr lang="de-DE" sz="1600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2" name="Grafik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0932" y="4721772"/>
            <a:ext cx="11297555" cy="13276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327442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feld 25"/>
          <p:cNvSpPr txBox="1"/>
          <p:nvPr/>
        </p:nvSpPr>
        <p:spPr>
          <a:xfrm>
            <a:off x="8021416" y="204274"/>
            <a:ext cx="14996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Pineocytomas</a:t>
            </a:r>
          </a:p>
        </p:txBody>
      </p:sp>
      <p:sp>
        <p:nvSpPr>
          <p:cNvPr id="42" name="Textfeld 41"/>
          <p:cNvSpPr txBox="1"/>
          <p:nvPr/>
        </p:nvSpPr>
        <p:spPr>
          <a:xfrm>
            <a:off x="292728" y="204638"/>
            <a:ext cx="5661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Pineal parenchymal tumors of intermediate </a:t>
            </a:r>
            <a:r>
              <a:rPr lang="de-DE" dirty="0" smtClean="0">
                <a:latin typeface="Calibri" panose="020F0502020204030204" pitchFamily="34" charset="0"/>
                <a:cs typeface="Calibri" panose="020F0502020204030204" pitchFamily="34" charset="0"/>
              </a:rPr>
              <a:t>differentiation</a:t>
            </a:r>
            <a:endParaRPr lang="de-DE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3ED72D56-6935-CDB6-2438-A60548697023}"/>
              </a:ext>
            </a:extLst>
          </p:cNvPr>
          <p:cNvSpPr txBox="1"/>
          <p:nvPr/>
        </p:nvSpPr>
        <p:spPr>
          <a:xfrm>
            <a:off x="7151511" y="5345507"/>
            <a:ext cx="1097281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*2nd highest score: PPTID_B 0.120; tSNE cluster with PPTID_B</a:t>
            </a:r>
            <a:endParaRPr lang="de-DE" sz="75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60833" y="4601409"/>
            <a:ext cx="1759518" cy="702263"/>
          </a:xfrm>
          <a:prstGeom prst="rect">
            <a:avLst/>
          </a:prstGeom>
        </p:spPr>
      </p:pic>
      <p:pic>
        <p:nvPicPr>
          <p:cNvPr id="12" name="Picture 2"/>
          <p:cNvPicPr>
            <a:picLocks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72" t="28859" r="11577" b="24601"/>
          <a:stretch/>
        </p:blipFill>
        <p:spPr bwMode="auto">
          <a:xfrm>
            <a:off x="8099232" y="540277"/>
            <a:ext cx="3780000" cy="2052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3" name="Picture 2"/>
          <p:cNvPicPr>
            <a:picLocks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00" t="29483" r="12009" b="24975"/>
          <a:stretch/>
        </p:blipFill>
        <p:spPr bwMode="auto">
          <a:xfrm>
            <a:off x="360000" y="540277"/>
            <a:ext cx="3780000" cy="2052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4" name="Picture 2"/>
          <p:cNvPicPr>
            <a:picLocks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30" t="28991" r="11597" b="24824"/>
          <a:stretch/>
        </p:blipFill>
        <p:spPr bwMode="auto">
          <a:xfrm>
            <a:off x="4245476" y="540277"/>
            <a:ext cx="3780000" cy="2052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15" name="Textfeld 14"/>
          <p:cNvSpPr txBox="1"/>
          <p:nvPr/>
        </p:nvSpPr>
        <p:spPr>
          <a:xfrm>
            <a:off x="255432" y="2546341"/>
            <a:ext cx="12883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PPTID-A (n=11)</a:t>
            </a:r>
            <a:endParaRPr lang="de-DE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4152992" y="2543096"/>
            <a:ext cx="1190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PPTID-B (n=4)</a:t>
            </a:r>
            <a:endParaRPr lang="de-DE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8011641" y="2549576"/>
            <a:ext cx="16345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Pineocytomas (n=6)</a:t>
            </a:r>
            <a:endParaRPr lang="de-DE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363307" y="6086415"/>
            <a:ext cx="11515925" cy="58477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de-DE" sz="16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Supplementary Figure 9:</a:t>
            </a:r>
          </a:p>
          <a:p>
            <a:pPr algn="just"/>
            <a:r>
              <a:rPr lang="de-DE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Detailed overview of the pineal parenchymal tumors of intermediate differentiation (PPTID) and the pineocytomas.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9" name="Grafik 8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7358400" y="2952000"/>
            <a:ext cx="4539600" cy="1260000"/>
          </a:xfrm>
          <a:prstGeom prst="rect">
            <a:avLst/>
          </a:prstGeom>
        </p:spPr>
      </p:pic>
      <p:pic>
        <p:nvPicPr>
          <p:cNvPr id="2" name="Grafik 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70312" y="2957899"/>
            <a:ext cx="6850251" cy="1923701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70304" y="4949595"/>
            <a:ext cx="6850259" cy="9853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34617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44</Words>
  <Application>Microsoft Office PowerPoint</Application>
  <PresentationFormat>Breitbild</PresentationFormat>
  <Paragraphs>147</Paragraphs>
  <Slides>9</Slides>
  <Notes>5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9</vt:i4>
      </vt:variant>
    </vt:vector>
  </HeadingPairs>
  <TitlesOfParts>
    <vt:vector size="14" baseType="lpstr">
      <vt:lpstr>Aptos</vt:lpstr>
      <vt:lpstr>Aptos Display</vt:lpstr>
      <vt:lpstr>Arial</vt:lpstr>
      <vt:lpstr>Calibri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obias Go</dc:creator>
  <cp:lastModifiedBy>Goschzik, Dr. Tobias</cp:lastModifiedBy>
  <cp:revision>101</cp:revision>
  <dcterms:created xsi:type="dcterms:W3CDTF">2024-07-11T14:25:54Z</dcterms:created>
  <dcterms:modified xsi:type="dcterms:W3CDTF">2025-09-19T12:54:01Z</dcterms:modified>
</cp:coreProperties>
</file>